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119813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95" userDrawn="1">
          <p15:clr>
            <a:srgbClr val="A4A3A4"/>
          </p15:clr>
        </p15:guide>
        <p15:guide id="2" pos="29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2290" y="77"/>
      </p:cViewPr>
      <p:guideLst>
        <p:guide orient="horz" pos="4195"/>
        <p:guide pos="29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178222"/>
            <a:ext cx="5201841" cy="250642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3781306"/>
            <a:ext cx="4589860" cy="1738167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2513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1281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383297"/>
            <a:ext cx="1319585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383297"/>
            <a:ext cx="3882256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342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0403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794831"/>
            <a:ext cx="5278339" cy="2994714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4817876"/>
            <a:ext cx="5278339" cy="15748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2538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916484"/>
            <a:ext cx="2600921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916484"/>
            <a:ext cx="2600921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217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83299"/>
            <a:ext cx="5278339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764832"/>
            <a:ext cx="2588967" cy="86491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629749"/>
            <a:ext cx="2588967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764832"/>
            <a:ext cx="2601718" cy="86491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629749"/>
            <a:ext cx="2601718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186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608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677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954"/>
            <a:ext cx="1973799" cy="1679840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036570"/>
            <a:ext cx="3098155" cy="5116178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159794"/>
            <a:ext cx="1973799" cy="400128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010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954"/>
            <a:ext cx="1973799" cy="1679840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036570"/>
            <a:ext cx="3098155" cy="5116178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159794"/>
            <a:ext cx="1973799" cy="400128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467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383299"/>
            <a:ext cx="5278339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916484"/>
            <a:ext cx="5278339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6672698"/>
            <a:ext cx="13769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8824C-A1D4-479E-8B3F-6C71572DE560}" type="datetimeFigureOut">
              <a:rPr kumimoji="1" lang="ja-JP" altLang="en-US" smtClean="0"/>
              <a:t>2019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6672698"/>
            <a:ext cx="206543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6672698"/>
            <a:ext cx="13769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60FE2-FD50-4FD5-99EF-B67906B59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908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オブジェクト 20">
            <a:extLst>
              <a:ext uri="{FF2B5EF4-FFF2-40B4-BE49-F238E27FC236}">
                <a16:creationId xmlns:a16="http://schemas.microsoft.com/office/drawing/2014/main" id="{D81CD573-7A36-4DC3-8608-7D8DFE0185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9267344"/>
              </p:ext>
            </p:extLst>
          </p:nvPr>
        </p:nvGraphicFramePr>
        <p:xfrm>
          <a:off x="947738" y="465243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8" name="Prism 5" r:id="rId3" imgW="1755720" imgH="1030320" progId="Prism5.Document">
                  <p:embed/>
                </p:oleObj>
              </mc:Choice>
              <mc:Fallback>
                <p:oleObj name="Prism 5" r:id="rId3" imgW="1755720" imgH="1030320" progId="Prism5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D2EC9701-1EA2-432A-ACEB-6C3F7A6D12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47738" y="465243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2D1F275-0182-4030-835F-154621CD02C7}"/>
              </a:ext>
            </a:extLst>
          </p:cNvPr>
          <p:cNvSpPr txBox="1"/>
          <p:nvPr/>
        </p:nvSpPr>
        <p:spPr>
          <a:xfrm>
            <a:off x="815353" y="1459575"/>
            <a:ext cx="2090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body weight (kg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EE5440B-AEAE-4DDF-823B-7D1BE357F2F6}"/>
              </a:ext>
            </a:extLst>
          </p:cNvPr>
          <p:cNvSpPr txBox="1"/>
          <p:nvPr/>
        </p:nvSpPr>
        <p:spPr>
          <a:xfrm>
            <a:off x="2162741" y="487421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0900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425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C3F751E8-2857-4AB0-8D90-664D8CB346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3625180"/>
              </p:ext>
            </p:extLst>
          </p:nvPr>
        </p:nvGraphicFramePr>
        <p:xfrm>
          <a:off x="952500" y="1665813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Prism 5" r:id="rId5" imgW="1755720" imgH="1030320" progId="Prism5.Document">
                  <p:embed/>
                </p:oleObj>
              </mc:Choice>
              <mc:Fallback>
                <p:oleObj name="Prism 5" r:id="rId5" imgW="1755720" imgH="1030320" progId="Prism5.Document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D8A21339-D63F-4190-8453-668EDC522B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52500" y="1665813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846B2BD-3758-48A9-AA99-9BBC49231928}"/>
              </a:ext>
            </a:extLst>
          </p:cNvPr>
          <p:cNvSpPr txBox="1"/>
          <p:nvPr/>
        </p:nvSpPr>
        <p:spPr>
          <a:xfrm>
            <a:off x="817104" y="2688257"/>
            <a:ext cx="2090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FBS (mg/dL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5D088AC-67B9-4135-89C0-3C023B98A7FC}"/>
              </a:ext>
            </a:extLst>
          </p:cNvPr>
          <p:cNvSpPr txBox="1"/>
          <p:nvPr/>
        </p:nvSpPr>
        <p:spPr>
          <a:xfrm>
            <a:off x="2162741" y="1702033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1474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184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オブジェクト 32">
            <a:extLst>
              <a:ext uri="{FF2B5EF4-FFF2-40B4-BE49-F238E27FC236}">
                <a16:creationId xmlns:a16="http://schemas.microsoft.com/office/drawing/2014/main" id="{13D3E186-EFDE-4F21-8C2A-DBFD7DE1D4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3935247"/>
              </p:ext>
            </p:extLst>
          </p:nvPr>
        </p:nvGraphicFramePr>
        <p:xfrm>
          <a:off x="949325" y="2967930"/>
          <a:ext cx="1755775" cy="1030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0" name="Prism 5" r:id="rId7" imgW="1755720" imgH="1029960" progId="Prism5.Document">
                  <p:embed/>
                </p:oleObj>
              </mc:Choice>
              <mc:Fallback>
                <p:oleObj name="Prism 5" r:id="rId7" imgW="1755720" imgH="1029960" progId="Prism5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DD2C22E2-D511-4A88-85DD-097EB9D767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49325" y="2967930"/>
                        <a:ext cx="1755775" cy="1030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8BBD61C-38E5-436C-8DCB-E7420E7BB7BA}"/>
              </a:ext>
            </a:extLst>
          </p:cNvPr>
          <p:cNvSpPr txBox="1"/>
          <p:nvPr/>
        </p:nvSpPr>
        <p:spPr>
          <a:xfrm>
            <a:off x="468474" y="3959393"/>
            <a:ext cx="27863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AST (U/L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E6BAD88-8F84-4E04-BA3F-FDADEAFEDCE5}"/>
              </a:ext>
            </a:extLst>
          </p:cNvPr>
          <p:cNvSpPr txBox="1"/>
          <p:nvPr/>
        </p:nvSpPr>
        <p:spPr>
          <a:xfrm>
            <a:off x="2154937" y="3005167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1276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250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9" name="オブジェクト 38">
            <a:extLst>
              <a:ext uri="{FF2B5EF4-FFF2-40B4-BE49-F238E27FC236}">
                <a16:creationId xmlns:a16="http://schemas.microsoft.com/office/drawing/2014/main" id="{924A6532-9CBC-47DD-A32A-947AB43F1D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5014209"/>
              </p:ext>
            </p:extLst>
          </p:nvPr>
        </p:nvGraphicFramePr>
        <p:xfrm>
          <a:off x="954088" y="4244633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1" name="Prism 5" r:id="rId9" imgW="1755720" imgH="1029960" progId="Prism5.Document">
                  <p:embed/>
                </p:oleObj>
              </mc:Choice>
              <mc:Fallback>
                <p:oleObj name="Prism 5" r:id="rId9" imgW="1755720" imgH="1029960" progId="Prism5.Document">
                  <p:embed/>
                  <p:pic>
                    <p:nvPicPr>
                      <p:cNvPr id="15" name="オブジェクト 14">
                        <a:extLst>
                          <a:ext uri="{FF2B5EF4-FFF2-40B4-BE49-F238E27FC236}">
                            <a16:creationId xmlns:a16="http://schemas.microsoft.com/office/drawing/2014/main" id="{8031876C-451E-400C-96E3-BAA46C738B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54088" y="4244633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78412F1-1B03-43B6-B454-B6B0ADC19EF6}"/>
              </a:ext>
            </a:extLst>
          </p:cNvPr>
          <p:cNvSpPr txBox="1"/>
          <p:nvPr/>
        </p:nvSpPr>
        <p:spPr>
          <a:xfrm>
            <a:off x="494466" y="5250650"/>
            <a:ext cx="27336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ALP (U/L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6978AA6-1BF4-42F2-8724-01D8E06961ED}"/>
              </a:ext>
            </a:extLst>
          </p:cNvPr>
          <p:cNvSpPr txBox="1"/>
          <p:nvPr/>
        </p:nvSpPr>
        <p:spPr>
          <a:xfrm>
            <a:off x="2153068" y="4277069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1772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115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オブジェクト 23">
            <a:extLst>
              <a:ext uri="{FF2B5EF4-FFF2-40B4-BE49-F238E27FC236}">
                <a16:creationId xmlns:a16="http://schemas.microsoft.com/office/drawing/2014/main" id="{1E1DC8E8-7102-47A4-9653-2086514215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4359077"/>
              </p:ext>
            </p:extLst>
          </p:nvPr>
        </p:nvGraphicFramePr>
        <p:xfrm>
          <a:off x="3843338" y="465243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2" name="Prism 5" r:id="rId11" imgW="1755720" imgH="1030320" progId="Prism5.Document">
                  <p:embed/>
                </p:oleObj>
              </mc:Choice>
              <mc:Fallback>
                <p:oleObj name="Prism 5" r:id="rId11" imgW="1755720" imgH="1030320" progId="Prism5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6AA0093B-3608-4D4C-B320-313BFCC032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43338" y="465243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 Box 486">
            <a:extLst>
              <a:ext uri="{FF2B5EF4-FFF2-40B4-BE49-F238E27FC236}">
                <a16:creationId xmlns:a16="http://schemas.microsoft.com/office/drawing/2014/main" id="{A74BB957-86EB-4123-BD2F-AC8BB97417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1581" y="402934"/>
            <a:ext cx="2792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 Box 486">
            <a:extLst>
              <a:ext uri="{FF2B5EF4-FFF2-40B4-BE49-F238E27FC236}">
                <a16:creationId xmlns:a16="http://schemas.microsoft.com/office/drawing/2014/main" id="{FA55B5C1-EA3E-488D-8699-41401CFA2C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396" y="2996133"/>
            <a:ext cx="2359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6" name="Text Box 486">
            <a:extLst>
              <a:ext uri="{FF2B5EF4-FFF2-40B4-BE49-F238E27FC236}">
                <a16:creationId xmlns:a16="http://schemas.microsoft.com/office/drawing/2014/main" id="{7B2D215C-6BCA-438C-BD50-3C5BE5371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4083" y="4250008"/>
            <a:ext cx="2792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7AE6B6F-4DB7-4052-B20E-F5F1C0B0EEB1}"/>
              </a:ext>
            </a:extLst>
          </p:cNvPr>
          <p:cNvSpPr txBox="1"/>
          <p:nvPr/>
        </p:nvSpPr>
        <p:spPr>
          <a:xfrm>
            <a:off x="2938870" y="865347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0B7386A-3FC3-4584-8D4D-E4D8521AA7F8}"/>
              </a:ext>
            </a:extLst>
          </p:cNvPr>
          <p:cNvSpPr txBox="1"/>
          <p:nvPr/>
        </p:nvSpPr>
        <p:spPr>
          <a:xfrm>
            <a:off x="3538630" y="1452066"/>
            <a:ext cx="23579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BMI (kg/m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6388699-4B5A-400F-8A51-4C28B8EEA8E0}"/>
              </a:ext>
            </a:extLst>
          </p:cNvPr>
          <p:cNvSpPr txBox="1"/>
          <p:nvPr/>
        </p:nvSpPr>
        <p:spPr>
          <a:xfrm>
            <a:off x="5015352" y="489987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1103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328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B1C5294-5507-4D47-B536-08C04B39B9B0}"/>
              </a:ext>
            </a:extLst>
          </p:cNvPr>
          <p:cNvSpPr txBox="1"/>
          <p:nvPr/>
        </p:nvSpPr>
        <p:spPr>
          <a:xfrm>
            <a:off x="3855138" y="2681668"/>
            <a:ext cx="1738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HbA1c (%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2CD7B02-261B-4323-8A43-EF2909691374}"/>
              </a:ext>
            </a:extLst>
          </p:cNvPr>
          <p:cNvSpPr txBox="1"/>
          <p:nvPr/>
        </p:nvSpPr>
        <p:spPr>
          <a:xfrm>
            <a:off x="5015352" y="1694032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0802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472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オブジェクト 35">
            <a:extLst>
              <a:ext uri="{FF2B5EF4-FFF2-40B4-BE49-F238E27FC236}">
                <a16:creationId xmlns:a16="http://schemas.microsoft.com/office/drawing/2014/main" id="{A249AB02-39B0-461B-B61E-55788ECC17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788818"/>
              </p:ext>
            </p:extLst>
          </p:nvPr>
        </p:nvGraphicFramePr>
        <p:xfrm>
          <a:off x="3848100" y="2975868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" name="Prism 5" r:id="rId13" imgW="1755720" imgH="1029960" progId="Prism5.Document">
                  <p:embed/>
                </p:oleObj>
              </mc:Choice>
              <mc:Fallback>
                <p:oleObj name="Prism 5" r:id="rId13" imgW="1755720" imgH="1029960" progId="Prism5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CC4C7975-2AD5-4918-B807-F483DCB659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48100" y="2975868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7724CB3-5E3C-4B38-AF97-C46FDAB88AB8}"/>
              </a:ext>
            </a:extLst>
          </p:cNvPr>
          <p:cNvSpPr txBox="1"/>
          <p:nvPr/>
        </p:nvSpPr>
        <p:spPr>
          <a:xfrm>
            <a:off x="5011718" y="3006946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02855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797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D771517-7AA4-4D4A-9F54-8392F7AD8973}"/>
              </a:ext>
            </a:extLst>
          </p:cNvPr>
          <p:cNvSpPr txBox="1"/>
          <p:nvPr/>
        </p:nvSpPr>
        <p:spPr>
          <a:xfrm>
            <a:off x="3476784" y="3953445"/>
            <a:ext cx="2489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ALT (U/L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" name="オブジェクト 41">
            <a:extLst>
              <a:ext uri="{FF2B5EF4-FFF2-40B4-BE49-F238E27FC236}">
                <a16:creationId xmlns:a16="http://schemas.microsoft.com/office/drawing/2014/main" id="{82A62B2A-C711-43C7-B73C-8E9F548D41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7311458"/>
              </p:ext>
            </p:extLst>
          </p:nvPr>
        </p:nvGraphicFramePr>
        <p:xfrm>
          <a:off x="3848100" y="4244633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4" name="Prism 5" r:id="rId15" imgW="1755720" imgH="1029960" progId="Prism5.Document">
                  <p:embed/>
                </p:oleObj>
              </mc:Choice>
              <mc:Fallback>
                <p:oleObj name="Prism 5" r:id="rId15" imgW="1755720" imgH="1029960" progId="Prism5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F8F6AC4C-F07C-4600-86BB-066AA3EEA9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848100" y="4244633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5BD9A8A-C853-4DBE-B526-D8C150B5B781}"/>
              </a:ext>
            </a:extLst>
          </p:cNvPr>
          <p:cNvSpPr txBox="1"/>
          <p:nvPr/>
        </p:nvSpPr>
        <p:spPr>
          <a:xfrm>
            <a:off x="3475488" y="5243514"/>
            <a:ext cx="24980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</a:t>
            </a:r>
            <a:r>
              <a:rPr kumimoji="1" lang="en-US" altLang="ja-JP" sz="800" dirty="0" err="1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GT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U/L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89F8B4E-5B0C-4BAA-B8D5-5A351A1D7602}"/>
              </a:ext>
            </a:extLst>
          </p:cNvPr>
          <p:cNvSpPr txBox="1"/>
          <p:nvPr/>
        </p:nvSpPr>
        <p:spPr>
          <a:xfrm>
            <a:off x="5013790" y="4267911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-0.01101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92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486">
            <a:extLst>
              <a:ext uri="{FF2B5EF4-FFF2-40B4-BE49-F238E27FC236}">
                <a16:creationId xmlns:a16="http://schemas.microsoft.com/office/drawing/2014/main" id="{7B1EE1A6-0891-45AE-88A0-4DA8C29B4F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0830" y="1653757"/>
            <a:ext cx="2792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B0A2F1E-2683-49FA-ADF0-347FCDC2B5CF}"/>
              </a:ext>
            </a:extLst>
          </p:cNvPr>
          <p:cNvSpPr txBox="1"/>
          <p:nvPr/>
        </p:nvSpPr>
        <p:spPr>
          <a:xfrm>
            <a:off x="2927440" y="3390633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C05219A-7E9E-467A-B021-D8AA9900628B}"/>
              </a:ext>
            </a:extLst>
          </p:cNvPr>
          <p:cNvSpPr txBox="1"/>
          <p:nvPr/>
        </p:nvSpPr>
        <p:spPr>
          <a:xfrm>
            <a:off x="2941264" y="4659208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graphicFrame>
        <p:nvGraphicFramePr>
          <p:cNvPr id="30" name="オブジェクト 29">
            <a:extLst>
              <a:ext uri="{FF2B5EF4-FFF2-40B4-BE49-F238E27FC236}">
                <a16:creationId xmlns:a16="http://schemas.microsoft.com/office/drawing/2014/main" id="{4574CBD7-43C0-4B03-9357-EE6642BBE8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5574879"/>
              </p:ext>
            </p:extLst>
          </p:nvPr>
        </p:nvGraphicFramePr>
        <p:xfrm>
          <a:off x="3844925" y="1668988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5" name="Prism 5" r:id="rId17" imgW="1755360" imgH="1030320" progId="Prism5.Document">
                  <p:embed/>
                </p:oleObj>
              </mc:Choice>
              <mc:Fallback>
                <p:oleObj name="Prism 5" r:id="rId17" imgW="1755360" imgH="1030320" progId="Prism5.Document">
                  <p:embed/>
                  <p:pic>
                    <p:nvPicPr>
                      <p:cNvPr id="12" name="オブジェクト 11">
                        <a:extLst>
                          <a:ext uri="{FF2B5EF4-FFF2-40B4-BE49-F238E27FC236}">
                            <a16:creationId xmlns:a16="http://schemas.microsoft.com/office/drawing/2014/main" id="{D60AEC61-8762-431C-BE50-3734BB144B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844925" y="1668988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871004-45ED-494F-941B-BB52737E52FF}"/>
              </a:ext>
            </a:extLst>
          </p:cNvPr>
          <p:cNvSpPr txBox="1"/>
          <p:nvPr/>
        </p:nvSpPr>
        <p:spPr>
          <a:xfrm>
            <a:off x="555659" y="131228"/>
            <a:ext cx="1559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486">
            <a:extLst>
              <a:ext uri="{FF2B5EF4-FFF2-40B4-BE49-F238E27FC236}">
                <a16:creationId xmlns:a16="http://schemas.microsoft.com/office/drawing/2014/main" id="{512AB86B-3119-422B-983B-84757DCB37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794" y="402934"/>
            <a:ext cx="2696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 Box 486">
            <a:extLst>
              <a:ext uri="{FF2B5EF4-FFF2-40B4-BE49-F238E27FC236}">
                <a16:creationId xmlns:a16="http://schemas.microsoft.com/office/drawing/2014/main" id="{C9084A23-2B76-4F20-9504-FF3D80C25C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794" y="1653757"/>
            <a:ext cx="2696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 Box 486">
            <a:extLst>
              <a:ext uri="{FF2B5EF4-FFF2-40B4-BE49-F238E27FC236}">
                <a16:creationId xmlns:a16="http://schemas.microsoft.com/office/drawing/2014/main" id="{9EB637AD-1D25-468A-8414-3540F284E7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794" y="2996133"/>
            <a:ext cx="2696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" name="Text Box 486">
            <a:extLst>
              <a:ext uri="{FF2B5EF4-FFF2-40B4-BE49-F238E27FC236}">
                <a16:creationId xmlns:a16="http://schemas.microsoft.com/office/drawing/2014/main" id="{78D85CEF-D290-45B5-B84D-55CEBF56C2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177" y="4245334"/>
            <a:ext cx="2792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1F7B80-4EAF-4EEE-8334-6416CD38C28F}"/>
              </a:ext>
            </a:extLst>
          </p:cNvPr>
          <p:cNvSpPr txBox="1"/>
          <p:nvPr/>
        </p:nvSpPr>
        <p:spPr>
          <a:xfrm>
            <a:off x="-1724" y="856220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48E9F72-D71F-4A26-9AE5-04279FB9299D}"/>
              </a:ext>
            </a:extLst>
          </p:cNvPr>
          <p:cNvSpPr txBox="1"/>
          <p:nvPr/>
        </p:nvSpPr>
        <p:spPr>
          <a:xfrm>
            <a:off x="-1724" y="2062717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ECB6642-E8EF-4DFA-864E-0E316C6CB904}"/>
              </a:ext>
            </a:extLst>
          </p:cNvPr>
          <p:cNvSpPr txBox="1"/>
          <p:nvPr/>
        </p:nvSpPr>
        <p:spPr>
          <a:xfrm>
            <a:off x="-1724" y="3380878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7084DD6-1F7D-4331-B60F-EB8C60005E92}"/>
              </a:ext>
            </a:extLst>
          </p:cNvPr>
          <p:cNvSpPr txBox="1"/>
          <p:nvPr/>
        </p:nvSpPr>
        <p:spPr>
          <a:xfrm>
            <a:off x="-1724" y="4659208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39B7F6C-D306-496D-A792-EDB1F3018AE4}"/>
              </a:ext>
            </a:extLst>
          </p:cNvPr>
          <p:cNvSpPr txBox="1"/>
          <p:nvPr/>
        </p:nvSpPr>
        <p:spPr>
          <a:xfrm>
            <a:off x="2927440" y="2062717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sp>
        <p:nvSpPr>
          <p:cNvPr id="45" name="Text Box 486">
            <a:extLst>
              <a:ext uri="{FF2B5EF4-FFF2-40B4-BE49-F238E27FC236}">
                <a16:creationId xmlns:a16="http://schemas.microsoft.com/office/drawing/2014/main" id="{278AFF6E-F507-498D-9573-8D132932C8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824" y="5488081"/>
            <a:ext cx="2279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6" name="Text Box 486">
            <a:extLst>
              <a:ext uri="{FF2B5EF4-FFF2-40B4-BE49-F238E27FC236}">
                <a16:creationId xmlns:a16="http://schemas.microsoft.com/office/drawing/2014/main" id="{CCBDDA1F-31B1-4AA8-96B9-A89CE1356F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6477" y="5488081"/>
            <a:ext cx="2279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CFFB9BB3-9F85-4B67-A411-0A50195CC6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192109"/>
              </p:ext>
            </p:extLst>
          </p:nvPr>
        </p:nvGraphicFramePr>
        <p:xfrm>
          <a:off x="952197" y="5522911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" name="Prism 5" r:id="rId19" imgW="1755720" imgH="1030320" progId="Prism5.Document">
                  <p:embed/>
                </p:oleObj>
              </mc:Choice>
              <mc:Fallback>
                <p:oleObj name="Prism 5" r:id="rId19" imgW="1755720" imgH="103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952197" y="5522911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CF0F214-1CE0-4CEF-9BBE-72296CEE1396}"/>
              </a:ext>
            </a:extLst>
          </p:cNvPr>
          <p:cNvSpPr txBox="1"/>
          <p:nvPr/>
        </p:nvSpPr>
        <p:spPr>
          <a:xfrm>
            <a:off x="493995" y="6507707"/>
            <a:ext cx="27336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WBC (/mm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F421D1B-AC96-4C6C-BECA-2A3F35F4BC74}"/>
              </a:ext>
            </a:extLst>
          </p:cNvPr>
          <p:cNvSpPr txBox="1"/>
          <p:nvPr/>
        </p:nvSpPr>
        <p:spPr>
          <a:xfrm>
            <a:off x="-11270" y="5961507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4A470091-58E9-4449-A6DF-67A35B0905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2004860"/>
              </p:ext>
            </p:extLst>
          </p:nvPr>
        </p:nvGraphicFramePr>
        <p:xfrm>
          <a:off x="3852716" y="5513083"/>
          <a:ext cx="1755775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" name="Prism 5" r:id="rId21" imgW="1755720" imgH="1030320" progId="Prism5.Document">
                  <p:embed/>
                </p:oleObj>
              </mc:Choice>
              <mc:Fallback>
                <p:oleObj name="Prism 5" r:id="rId21" imgW="1755720" imgH="103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852716" y="5513083"/>
                        <a:ext cx="1755775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C7B4776-0FBC-414A-9F86-5D5B065238B6}"/>
              </a:ext>
            </a:extLst>
          </p:cNvPr>
          <p:cNvSpPr txBox="1"/>
          <p:nvPr/>
        </p:nvSpPr>
        <p:spPr>
          <a:xfrm>
            <a:off x="3475002" y="6508364"/>
            <a:ext cx="24980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in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Plt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×10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/mm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CFD3E33-A64F-475E-B834-577B81C43C13}"/>
              </a:ext>
            </a:extLst>
          </p:cNvPr>
          <p:cNvSpPr txBox="1"/>
          <p:nvPr/>
        </p:nvSpPr>
        <p:spPr>
          <a:xfrm>
            <a:off x="2153068" y="5517090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-0.1206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278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7F39B2D-8DF7-4299-A634-14C501589415}"/>
              </a:ext>
            </a:extLst>
          </p:cNvPr>
          <p:cNvSpPr txBox="1"/>
          <p:nvPr/>
        </p:nvSpPr>
        <p:spPr>
          <a:xfrm>
            <a:off x="5011718" y="5517090"/>
            <a:ext cx="1488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-0.0403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718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7E68C28-CA4A-4B30-86F5-B643734D7D04}"/>
              </a:ext>
            </a:extLst>
          </p:cNvPr>
          <p:cNvSpPr txBox="1"/>
          <p:nvPr/>
        </p:nvSpPr>
        <p:spPr>
          <a:xfrm>
            <a:off x="2938870" y="5961507"/>
            <a:ext cx="1915272" cy="338554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ecrease 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log-UACR</a:t>
            </a:r>
          </a:p>
        </p:txBody>
      </p:sp>
    </p:spTree>
    <p:extLst>
      <p:ext uri="{BB962C8B-B14F-4D97-AF65-F5344CB8AC3E}">
        <p14:creationId xmlns:p14="http://schemas.microsoft.com/office/powerpoint/2010/main" val="164930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179</Words>
  <Application>Microsoft Office PowerPoint</Application>
  <PresentationFormat>ユーザー設定</PresentationFormat>
  <Paragraphs>6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テーマ</vt:lpstr>
      <vt:lpstr>Prism 5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翔 金口</dc:creator>
  <cp:lastModifiedBy>翔 金口</cp:lastModifiedBy>
  <cp:revision>12</cp:revision>
  <dcterms:created xsi:type="dcterms:W3CDTF">2019-05-01T10:59:33Z</dcterms:created>
  <dcterms:modified xsi:type="dcterms:W3CDTF">2019-07-03T11:00:19Z</dcterms:modified>
</cp:coreProperties>
</file>